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</p:sldIdLst>
  <p:sldSz cx="9144000" cy="6858000" type="screen4x3"/>
  <p:notesSz cx="6797675" cy="992822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996A99-55B2-447E-A889-CB0B292CF3F6}" type="datetimeFigureOut">
              <a:rPr lang="zh-CN" altLang="en-US" smtClean="0"/>
              <a:pPr/>
              <a:t>2019/3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71CD9D-2DD7-43DD-AF58-FDD323CE8D0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07704" y="2996952"/>
            <a:ext cx="2705100" cy="1666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611560" y="54868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Figure 1A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55576" y="1196752"/>
            <a:ext cx="1835696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                             ACTB        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    </a:t>
            </a:r>
          </a:p>
          <a:p>
            <a:r>
              <a:rPr lang="en-US" altLang="zh-CN" dirty="0" smtClean="0"/>
              <a:t>PRDM10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Bcl-2 </a:t>
            </a:r>
            <a:endParaRPr lang="zh-CN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07704" y="4905375"/>
            <a:ext cx="2733675" cy="1952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35696" y="1196752"/>
            <a:ext cx="3184277" cy="15121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560" y="54868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Figure 2A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55576" y="1196752"/>
            <a:ext cx="1835696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                             ACTB        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    </a:t>
            </a:r>
          </a:p>
          <a:p>
            <a:r>
              <a:rPr lang="en-US" altLang="zh-CN" dirty="0" smtClean="0"/>
              <a:t>PRDM10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Bcl-2 </a:t>
            </a:r>
            <a:endParaRPr lang="zh-CN" altLang="en-US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835696" y="1484784"/>
            <a:ext cx="2324100" cy="1504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07704" y="3356992"/>
            <a:ext cx="2676525" cy="1085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35696" y="5157192"/>
            <a:ext cx="2714625" cy="1381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11560" y="548680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Figure 2b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55576" y="1196752"/>
            <a:ext cx="1835696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                             ACTB        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    </a:t>
            </a:r>
          </a:p>
          <a:p>
            <a:r>
              <a:rPr lang="en-US" altLang="zh-CN" dirty="0" smtClean="0"/>
              <a:t>PRDM10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r>
              <a:rPr lang="en-US" altLang="zh-CN" dirty="0" smtClean="0"/>
              <a:t>                                     Bcl-2 </a:t>
            </a:r>
            <a:endParaRPr lang="zh-CN" alt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r="29895"/>
          <a:stretch>
            <a:fillRect/>
          </a:stretch>
        </p:blipFill>
        <p:spPr bwMode="auto">
          <a:xfrm>
            <a:off x="1619672" y="1484784"/>
            <a:ext cx="2664296" cy="876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t="39789" r="24797" b="528"/>
          <a:stretch>
            <a:fillRect/>
          </a:stretch>
        </p:blipFill>
        <p:spPr bwMode="auto">
          <a:xfrm>
            <a:off x="1691680" y="5661248"/>
            <a:ext cx="2736304" cy="6480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 r="17488"/>
          <a:stretch>
            <a:fillRect/>
          </a:stretch>
        </p:blipFill>
        <p:spPr bwMode="auto">
          <a:xfrm>
            <a:off x="1763688" y="3501008"/>
            <a:ext cx="2664296" cy="895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404664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Figure 3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47664" y="2204864"/>
            <a:ext cx="571500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23528" y="404664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Figure 3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56176" y="2780928"/>
            <a:ext cx="590550" cy="876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35696" y="2636912"/>
            <a:ext cx="55245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3</TotalTime>
  <Words>31</Words>
  <Application>Microsoft Office PowerPoint</Application>
  <PresentationFormat>全屏显示(4:3)</PresentationFormat>
  <Paragraphs>53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Company>M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-</dc:creator>
  <cp:lastModifiedBy>USER-</cp:lastModifiedBy>
  <cp:revision>72</cp:revision>
  <dcterms:created xsi:type="dcterms:W3CDTF">2019-02-27T06:52:24Z</dcterms:created>
  <dcterms:modified xsi:type="dcterms:W3CDTF">2019-03-20T11:41:17Z</dcterms:modified>
</cp:coreProperties>
</file>